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1" r:id="rId2"/>
    <p:sldId id="275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Ryan, Edward T.,M.D." initials="RET" lastIdx="7" clrIdx="0">
    <p:extLst>
      <p:ext uri="{19B8F6BF-5375-455C-9EA6-DF929625EA0E}">
        <p15:presenceInfo xmlns:p15="http://schemas.microsoft.com/office/powerpoint/2012/main" userId="S-1-5-21-8915387-943144406-1916815836-25268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97" d="100"/>
          <a:sy n="97" d="100"/>
        </p:scale>
        <p:origin x="96" y="11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75BA502-F328-4E76-801F-02EE2307F90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A3D972F-0D2B-4935-98AB-182526A4D33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1879538-F869-4B72-B3D2-EDFBD3030B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79D954-7934-423A-B04A-833763C6C67D}" type="datetimeFigureOut">
              <a:rPr lang="en-US" smtClean="0"/>
              <a:t>10/1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91A7040-C4FB-4E3B-87CE-0C5A17DC61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0FE004D-7F83-4670-85EB-4CC6CE1566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E0671-3ED9-4D28-8D86-BF906D8C3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42399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7978F4-695F-4F7B-A082-6C4769B67CC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1104D9D-0A81-41F1-A212-860FA7783B8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7751CC2-55BE-4339-B9B5-CBF940CA1C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79D954-7934-423A-B04A-833763C6C67D}" type="datetimeFigureOut">
              <a:rPr lang="en-US" smtClean="0"/>
              <a:t>10/1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7031E5F-4383-4978-9B22-C3B0BBA663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912B9E2-2D75-4C44-87B3-B69393CD8D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E0671-3ED9-4D28-8D86-BF906D8C3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80675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53E2FAB-F728-46F2-A2EB-F32DE030E6E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3258111-6159-41C3-B79E-0056033B2D1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80ED1FE-0774-4E7C-B3F3-2169054FBC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79D954-7934-423A-B04A-833763C6C67D}" type="datetimeFigureOut">
              <a:rPr lang="en-US" smtClean="0"/>
              <a:t>10/1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EC3F27A-C69E-4A4D-A99E-E3655FC2BC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23665A6-B42C-435E-8CDE-BEF7780737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E0671-3ED9-4D28-8D86-BF906D8C3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0434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465138-CB44-451D-A817-366801FC8F7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2F251FC-CF00-4887-92A4-EED5243A006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66BAA48-E76C-430B-B64A-B3CCD5B2CF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79D954-7934-423A-B04A-833763C6C67D}" type="datetimeFigureOut">
              <a:rPr lang="en-US" smtClean="0"/>
              <a:t>10/1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47D58D1-CCFE-4C30-9918-42D9085D5B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5E9FA19-6B85-4913-A2F7-B7ED1A37E4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E0671-3ED9-4D28-8D86-BF906D8C3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4446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D4EFA8-A4D3-4931-8FE6-DAAC8DCDDB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FA7BAAD-0FB3-4291-8651-7880D4861B6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73B4443-9B10-4BAC-8048-918581CC15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79D954-7934-423A-B04A-833763C6C67D}" type="datetimeFigureOut">
              <a:rPr lang="en-US" smtClean="0"/>
              <a:t>10/1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AE89B3A-FCA0-4EBA-B12D-B5F9A5DD96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B4B35DB-67D2-4B5B-A41A-FD33FB63B3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E0671-3ED9-4D28-8D86-BF906D8C3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90005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DF6D88E-F710-488A-9860-7D9C093F4D6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B7EAEFA-C2F3-472A-B60C-DAE796455EB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E1F468C-612D-476D-9FAE-BFC8B9A74DD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8B09373-BF63-4541-A42A-9BB188CFF7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79D954-7934-423A-B04A-833763C6C67D}" type="datetimeFigureOut">
              <a:rPr lang="en-US" smtClean="0"/>
              <a:t>10/19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B98B675-A572-4A23-867F-FB0B4DF737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440CBE6-7D4C-42DC-B5F7-F00A3157D5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E0671-3ED9-4D28-8D86-BF906D8C3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01271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AD2CBBD-EBBD-43C4-8E93-D4077A6C7F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7711195-184A-4BA5-A9F0-9D9DCFA6EA9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B7531FF-CD52-4A08-98FF-FCE995C6791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10E03D8-D93E-4C6A-82CA-311139A6784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AF3401A-D679-4D91-A3D6-1BFEC924F89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4FD359E-598F-48C1-9919-AA4F9A618B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79D954-7934-423A-B04A-833763C6C67D}" type="datetimeFigureOut">
              <a:rPr lang="en-US" smtClean="0"/>
              <a:t>10/19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ABFA28E-DC05-4A5E-80D0-463820DA6C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35DF75A-6B30-432D-8069-36B7C60817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E0671-3ED9-4D28-8D86-BF906D8C3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18348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781EE9-65FE-4FC5-BC37-CD61273F9C8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DCDDD91-0236-4B60-926D-72067C18AC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79D954-7934-423A-B04A-833763C6C67D}" type="datetimeFigureOut">
              <a:rPr lang="en-US" smtClean="0"/>
              <a:t>10/19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F4BE5D6-2FF5-4D5B-A6B1-82B41B79C7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DCF9DE8-7C6E-4F4D-8EA8-7259386AE7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E0671-3ED9-4D28-8D86-BF906D8C3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02208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A7E4491-788A-4821-9E6E-570A8CE61D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79D954-7934-423A-B04A-833763C6C67D}" type="datetimeFigureOut">
              <a:rPr lang="en-US" smtClean="0"/>
              <a:t>10/19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EB716BC-9E60-4DEA-A07B-80BD02145D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0D0791B-A499-45CD-8F78-DA9BE7D307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E0671-3ED9-4D28-8D86-BF906D8C3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90504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D088561-81FB-43F0-AE7A-35A3626482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483C397-50A4-4C0C-B407-0138AE86AB8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8B49911-E1A7-485F-8AB1-60951F9F821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0B1B66C-7CBC-4C89-A559-1287879948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79D954-7934-423A-B04A-833763C6C67D}" type="datetimeFigureOut">
              <a:rPr lang="en-US" smtClean="0"/>
              <a:t>10/19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274D22C-025D-4125-A048-33F23A3A98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B255B70-97CF-4715-83C6-6ADAF3E23A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E0671-3ED9-4D28-8D86-BF906D8C3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5233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B4FC6C-F436-486E-9F5D-CB67FA0E3A1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CCFC830-4DC3-4C31-8286-900695D144B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40CFC38-6DC0-4B24-9B16-723421F6545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9446571-AE5F-4C6D-A1E8-85F1A45A71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79D954-7934-423A-B04A-833763C6C67D}" type="datetimeFigureOut">
              <a:rPr lang="en-US" smtClean="0"/>
              <a:t>10/19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8C8367C-6D79-4E70-B7B1-590275D59D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4F8B58E-1339-4343-8DE4-B6BFD476A9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E0671-3ED9-4D28-8D86-BF906D8C3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9569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2B21B23-1BE5-4230-8070-F5D9436C07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053AED6-C2E9-4DA5-B4A7-73250757F4E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2729CA7-A24A-4A68-BC90-765289BA885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79D954-7934-423A-B04A-833763C6C67D}" type="datetimeFigureOut">
              <a:rPr lang="en-US" smtClean="0"/>
              <a:t>10/1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2B8A1B4-6CAD-452C-B2DF-90DB79436B9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973B7F6-D911-46CA-9FD0-EBCAED55DAF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BE0671-3ED9-4D28-8D86-BF906D8C3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20487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57064A0-E636-4F00-ADAA-B8117F0F4D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702676" y="2207172"/>
            <a:ext cx="8584324" cy="2766849"/>
          </a:xfrm>
        </p:spPr>
        <p:txBody>
          <a:bodyPr>
            <a:normAutofit fontScale="90000"/>
          </a:bodyPr>
          <a:lstStyle/>
          <a:p>
            <a:r>
              <a:rPr lang="en-US" b="1" dirty="0"/>
              <a:t>Supplemental Figure 2:</a:t>
            </a:r>
            <a:br>
              <a:rPr lang="en-US" b="1" dirty="0"/>
            </a:br>
            <a:r>
              <a:rPr lang="en-US" sz="1800" b="1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Figure S2</a:t>
            </a:r>
            <a:r>
              <a:rPr lang="en-US" sz="18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. </a:t>
            </a:r>
            <a:r>
              <a:rPr lang="en-US" sz="1800" b="1" baseline="300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13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C-NMR Comparison of OSP produced by </a:t>
            </a:r>
            <a:r>
              <a:rPr lang="en-US" sz="1800" b="1" dirty="0" err="1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Eubiologics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(black) with standard (red)</a:t>
            </a:r>
            <a:r>
              <a:rPr lang="en-US" sz="1800" dirty="0">
                <a:effectLst/>
                <a:latin typeface="Calibri" panose="020F050202020403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[75]</a:t>
            </a:r>
            <a:r>
              <a:rPr lang="en-US" sz="18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.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</a:t>
            </a:r>
            <a:r>
              <a:rPr lang="en-US" sz="1800" baseline="300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13</a:t>
            </a:r>
            <a:r>
              <a:rPr lang="en-US" sz="18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C-NMR experiments were measured in D</a:t>
            </a:r>
            <a:r>
              <a:rPr lang="en-US" sz="1800" baseline="-250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2</a:t>
            </a:r>
            <a:r>
              <a:rPr lang="en-US" sz="18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O at 25</a:t>
            </a:r>
            <a:r>
              <a:rPr lang="en-US" sz="18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  <a:sym typeface="Symbol" panose="05050102010706020507" pitchFamily="18" charset="2"/>
              </a:rPr>
              <a:t></a:t>
            </a:r>
            <a:r>
              <a:rPr lang="en-US" sz="18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C in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Shigemi</a:t>
            </a:r>
            <a:r>
              <a:rPr lang="en-US" sz="18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NMR tube, at 150 MHz on a Bruker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Avance</a:t>
            </a:r>
            <a:r>
              <a:rPr lang="en-US" sz="18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Spectrometer with a TCI cryoprobe. Samples were prepared at ~10 mg/mL concentration.</a:t>
            </a:r>
            <a:br>
              <a:rPr lang="en-US" sz="1800" dirty="0">
                <a:effectLst/>
                <a:latin typeface="Calibri" panose="020F050202020403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</a:br>
            <a:br>
              <a:rPr lang="en-US" b="1" dirty="0"/>
            </a:b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41048504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3" descr="Screen Shot 2020-06-03 at 2.21.44 PM.png">
            <a:extLst>
              <a:ext uri="{FF2B5EF4-FFF2-40B4-BE49-F238E27FC236}">
                <a16:creationId xmlns:a16="http://schemas.microsoft.com/office/drawing/2014/main" id="{5A4A78CA-7758-4E13-8F51-17BE5E86C90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35837" y="1826123"/>
            <a:ext cx="9144000" cy="4603387"/>
          </a:xfrm>
          <a:prstGeom prst="rect">
            <a:avLst/>
          </a:prstGeom>
        </p:spPr>
      </p:pic>
      <p:sp>
        <p:nvSpPr>
          <p:cNvPr id="7" name="Rectangle 4">
            <a:extLst>
              <a:ext uri="{FF2B5EF4-FFF2-40B4-BE49-F238E27FC236}">
                <a16:creationId xmlns:a16="http://schemas.microsoft.com/office/drawing/2014/main" id="{15F4B7AC-4F50-4DD2-B37B-43848E79B01E}"/>
              </a:ext>
            </a:extLst>
          </p:cNvPr>
          <p:cNvSpPr/>
          <p:nvPr/>
        </p:nvSpPr>
        <p:spPr>
          <a:xfrm>
            <a:off x="2153249" y="796852"/>
            <a:ext cx="8404766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400" baseline="30000" dirty="0"/>
              <a:t>13</a:t>
            </a:r>
            <a:r>
              <a:rPr lang="en-US" sz="2400" dirty="0"/>
              <a:t>C-NMR comparison of OSP-P2012-1 (black) and standard (red) 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44A7DE9D-C94E-4813-9FE2-25E88F24F4E0}"/>
              </a:ext>
            </a:extLst>
          </p:cNvPr>
          <p:cNvSpPr txBox="1"/>
          <p:nvPr/>
        </p:nvSpPr>
        <p:spPr>
          <a:xfrm>
            <a:off x="4799189" y="4203685"/>
            <a:ext cx="26052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Eub</a:t>
            </a:r>
            <a:r>
              <a:rPr lang="en-US" dirty="0"/>
              <a:t> sample: OSP-P2012-1</a:t>
            </a:r>
          </a:p>
        </p:txBody>
      </p:sp>
      <p:sp>
        <p:nvSpPr>
          <p:cNvPr id="9" name="Rectangle 6">
            <a:extLst>
              <a:ext uri="{FF2B5EF4-FFF2-40B4-BE49-F238E27FC236}">
                <a16:creationId xmlns:a16="http://schemas.microsoft.com/office/drawing/2014/main" id="{8D5871A3-9EF9-4C98-B8C5-87DEC2E55C04}"/>
              </a:ext>
            </a:extLst>
          </p:cNvPr>
          <p:cNvSpPr/>
          <p:nvPr/>
        </p:nvSpPr>
        <p:spPr>
          <a:xfrm>
            <a:off x="4799189" y="5897418"/>
            <a:ext cx="238924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err="1">
                <a:solidFill>
                  <a:srgbClr val="FF0000"/>
                </a:solidFill>
              </a:rPr>
              <a:t>V.c</a:t>
            </a:r>
            <a:r>
              <a:rPr lang="en-US" dirty="0">
                <a:solidFill>
                  <a:srgbClr val="FF0000"/>
                </a:solidFill>
              </a:rPr>
              <a:t>. Inaba OSP standard</a:t>
            </a:r>
          </a:p>
        </p:txBody>
      </p:sp>
      <p:sp>
        <p:nvSpPr>
          <p:cNvPr id="10" name="제목 3">
            <a:extLst>
              <a:ext uri="{FF2B5EF4-FFF2-40B4-BE49-F238E27FC236}">
                <a16:creationId xmlns:a16="http://schemas.microsoft.com/office/drawing/2014/main" id="{99FD46A7-81CF-4604-A0EF-F272585DB09D}"/>
              </a:ext>
            </a:extLst>
          </p:cNvPr>
          <p:cNvSpPr txBox="1">
            <a:spLocks/>
          </p:cNvSpPr>
          <p:nvPr/>
        </p:nvSpPr>
        <p:spPr>
          <a:xfrm>
            <a:off x="322127" y="210594"/>
            <a:ext cx="10515600" cy="646929"/>
          </a:xfrm>
          <a:prstGeom prst="rect">
            <a:avLst/>
          </a:prstGeom>
        </p:spPr>
        <p:txBody>
          <a:bodyPr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2400" b="1" dirty="0">
                <a:latin typeface="Arial" panose="020B0604020202020204" pitchFamily="34" charset="0"/>
                <a:cs typeface="Arial" panose="020B0604020202020204" pitchFamily="34" charset="0"/>
              </a:rPr>
              <a:t>OSP-P2012 by </a:t>
            </a:r>
            <a:r>
              <a:rPr lang="en-US" altLang="ko-KR" sz="24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  <a:r>
              <a:rPr lang="en-US" altLang="ko-KR" sz="2400" b="1" dirty="0">
                <a:latin typeface="Arial" panose="020B0604020202020204" pitchFamily="34" charset="0"/>
                <a:cs typeface="Arial" panose="020B0604020202020204" pitchFamily="34" charset="0"/>
              </a:rPr>
              <a:t>C-NMR</a:t>
            </a:r>
            <a:endParaRPr lang="ko-KR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068059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50</TotalTime>
  <Words>93</Words>
  <Application>Microsoft Office PowerPoint</Application>
  <PresentationFormat>Widescreen</PresentationFormat>
  <Paragraphs>5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Supplemental Figure 2: Figure S2. 13C-NMR Comparison of OSP produced by Eubiologics (black) with standard (red) [75]. 13C-NMR experiments were measured in D2O at 25C in Shigemi NMR tube, at 150 MHz on a Bruker Avance Spectrometer with a TCI cryoprobe. Samples were prepared at ~10 mg/mL concentration.  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elly, Meagan</dc:creator>
  <cp:lastModifiedBy>Ryan, Edward T.,M.D.</cp:lastModifiedBy>
  <cp:revision>68</cp:revision>
  <cp:lastPrinted>2021-06-03T18:55:09Z</cp:lastPrinted>
  <dcterms:created xsi:type="dcterms:W3CDTF">2020-08-13T18:26:36Z</dcterms:created>
  <dcterms:modified xsi:type="dcterms:W3CDTF">2021-10-19T17:26:29Z</dcterms:modified>
</cp:coreProperties>
</file>